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24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F74ED6"/>
    <a:srgbClr val="05BE78"/>
    <a:srgbClr val="FF8080"/>
    <a:srgbClr val="FFFFFF"/>
    <a:srgbClr val="0000FF"/>
    <a:srgbClr val="76069A"/>
    <a:srgbClr val="FF8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875"/>
    <p:restoredTop sz="94682"/>
  </p:normalViewPr>
  <p:slideViewPr>
    <p:cSldViewPr snapToGrid="0">
      <p:cViewPr varScale="1">
        <p:scale>
          <a:sx n="69" d="100"/>
          <a:sy n="69" d="100"/>
        </p:scale>
        <p:origin x="1788" y="84"/>
      </p:cViewPr>
      <p:guideLst>
        <p:guide orient="horz" pos="16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35" tIns="45718" rIns="91435" bIns="45718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35" tIns="45718" rIns="91435" bIns="45718" rtlCol="0"/>
          <a:lstStyle>
            <a:lvl1pPr algn="r">
              <a:defRPr sz="1200"/>
            </a:lvl1pPr>
          </a:lstStyle>
          <a:p>
            <a:fld id="{2781702D-12D0-4839-A3CC-B3169D578D6E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2225" y="1143000"/>
            <a:ext cx="17335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5" tIns="45718" rIns="91435" bIns="45718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35" tIns="45718" rIns="91435" bIns="45718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4"/>
            <a:ext cx="2971800" cy="458787"/>
          </a:xfrm>
          <a:prstGeom prst="rect">
            <a:avLst/>
          </a:prstGeom>
        </p:spPr>
        <p:txBody>
          <a:bodyPr vert="horz" lIns="91435" tIns="45718" rIns="91435" bIns="45718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4"/>
            <a:ext cx="2971800" cy="458787"/>
          </a:xfrm>
          <a:prstGeom prst="rect">
            <a:avLst/>
          </a:prstGeom>
        </p:spPr>
        <p:txBody>
          <a:bodyPr vert="horz" lIns="91435" tIns="45718" rIns="91435" bIns="45718" rtlCol="0" anchor="b"/>
          <a:lstStyle>
            <a:lvl1pPr algn="r">
              <a:defRPr sz="1200"/>
            </a:lvl1pPr>
          </a:lstStyle>
          <a:p>
            <a:fld id="{6319DB23-573F-4C71-BB24-19F8F211EC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4797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8482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1681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43439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14372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9021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92755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8411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9106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63754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802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765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2708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5">
            <a:extLst>
              <a:ext uri="{FF2B5EF4-FFF2-40B4-BE49-F238E27FC236}">
                <a16:creationId xmlns:a16="http://schemas.microsoft.com/office/drawing/2014/main" id="{B3699401-E4FB-F97F-67A8-8C2A0D5AF87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575" y="2398713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2" name="Picture 1" descr="A black background with blue green and purple lines&#10;&#10;AI-generated content may be incorrect.">
            <a:extLst>
              <a:ext uri="{FF2B5EF4-FFF2-40B4-BE49-F238E27FC236}">
                <a16:creationId xmlns:a16="http://schemas.microsoft.com/office/drawing/2014/main" id="{AAD2AE8E-599F-E473-2162-B27D8829985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8437" y="884419"/>
            <a:ext cx="3681955" cy="2627651"/>
          </a:xfrm>
          <a:prstGeom prst="rect">
            <a:avLst/>
          </a:prstGeom>
        </p:spPr>
      </p:pic>
      <p:sp>
        <p:nvSpPr>
          <p:cNvPr id="3" name="Text Box 2">
            <a:extLst>
              <a:ext uri="{FF2B5EF4-FFF2-40B4-BE49-F238E27FC236}">
                <a16:creationId xmlns:a16="http://schemas.microsoft.com/office/drawing/2014/main" id="{E661B962-B022-62A8-524B-49501FFD5DC2}"/>
              </a:ext>
            </a:extLst>
          </p:cNvPr>
          <p:cNvSpPr txBox="1"/>
          <p:nvPr/>
        </p:nvSpPr>
        <p:spPr>
          <a:xfrm>
            <a:off x="213677" y="3881594"/>
            <a:ext cx="6430645" cy="98107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US" sz="1100" b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igure S16</a:t>
            </a:r>
            <a:r>
              <a:rPr lang="en-US" sz="1100" b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  Survival of mice treated with +/- RER and +/- radiation therapy. </a:t>
            </a:r>
            <a:r>
              <a:rPr lang="en-US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Tumors were established utilizing the TC32 cell line hu-CD34+ mice. 3 weeks following tumor injection mice were treated with +/- radiation therapy (5 Gy dose x 1) and +/- TGF</a:t>
            </a:r>
            <a:r>
              <a:rPr lang="en-US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  <a:sym typeface="Symbol" pitchFamily="2" charset="2"/>
              </a:rPr>
              <a:t></a:t>
            </a:r>
            <a:r>
              <a:rPr lang="en-US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inhibition with daily RER injection (or PBS control). </a:t>
            </a:r>
            <a:r>
              <a:rPr lang="en-US" sz="10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</a:t>
            </a:r>
            <a:r>
              <a:rPr lang="en-US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Time from tumor injection to survival was determined using pre-specified endpoints for survival (see methods). Kaplan Meier estimate was used for analysis. p-value  was &gt; 0.05 for all comparisons (non-significant). </a:t>
            </a:r>
            <a:endParaRPr lang="en-US" sz="12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823380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9ef9f489-e0a0-4eeb-87cc-3a526112fd0d}" enabled="0" method="" siteId="{9ef9f489-e0a0-4eeb-87cc-3a526112fd0d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95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ley, Jessica</dc:creator>
  <cp:lastModifiedBy>Bailey, Kelly Margaret</cp:lastModifiedBy>
  <cp:revision>5</cp:revision>
  <cp:lastPrinted>2025-05-16T17:21:58Z</cp:lastPrinted>
  <dcterms:created xsi:type="dcterms:W3CDTF">2024-03-08T16:05:53Z</dcterms:created>
  <dcterms:modified xsi:type="dcterms:W3CDTF">2025-07-22T15:11:17Z</dcterms:modified>
</cp:coreProperties>
</file>